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0" r:id="rId2"/>
    <p:sldId id="285" r:id="rId3"/>
    <p:sldId id="286" r:id="rId4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639" autoAdjust="0"/>
    <p:restoredTop sz="95441" autoAdjust="0"/>
  </p:normalViewPr>
  <p:slideViewPr>
    <p:cSldViewPr>
      <p:cViewPr varScale="1">
        <p:scale>
          <a:sx n="86" d="100"/>
          <a:sy n="86" d="100"/>
        </p:scale>
        <p:origin x="3442" y="5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0D88E7-EA9A-45AF-8A30-15778BEC683F}" type="datetimeFigureOut">
              <a:rPr lang="en-GB" smtClean="0"/>
              <a:t>17/11/2023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6B8F4D-53EB-4552-9D6F-BF1F9DF49639}" type="slidenum">
              <a:rPr lang="en-GB" smtClean="0"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Image 2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4704" y="7095823"/>
            <a:ext cx="5244912" cy="1987324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64704" y="5075640"/>
            <a:ext cx="5256584" cy="1944632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80738" y="2744918"/>
            <a:ext cx="5155260" cy="1905512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09530" y="734416"/>
            <a:ext cx="5383785" cy="1984018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30041" y="126442"/>
            <a:ext cx="648072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b="1" dirty="0" smtClean="0"/>
              <a:t>S5 </a:t>
            </a:r>
            <a:r>
              <a:rPr lang="en-GB" sz="1400" b="1" dirty="0"/>
              <a:t>Fig</a:t>
            </a:r>
            <a:r>
              <a:rPr lang="en-GB" sz="1400" dirty="0"/>
              <a:t>. </a:t>
            </a:r>
            <a:r>
              <a:rPr lang="en-GB" sz="1400" dirty="0" smtClean="0"/>
              <a:t>Results of bacteria inoculation test on the seedlings growth promotion. </a:t>
            </a:r>
            <a:endParaRPr lang="fr-FR" sz="1400" dirty="0" smtClean="0"/>
          </a:p>
        </p:txBody>
      </p:sp>
      <p:sp>
        <p:nvSpPr>
          <p:cNvPr id="5" name="ZoneTexte 4"/>
          <p:cNvSpPr txBox="1"/>
          <p:nvPr/>
        </p:nvSpPr>
        <p:spPr>
          <a:xfrm>
            <a:off x="620688" y="467544"/>
            <a:ext cx="782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rgbClr val="0070C0"/>
                </a:solidFill>
              </a:rPr>
              <a:t>TS2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620688" y="4798347"/>
            <a:ext cx="1562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rgbClr val="0070C0"/>
                </a:solidFill>
              </a:rPr>
              <a:t>ORYLUX 6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052736" y="899592"/>
            <a:ext cx="1394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1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1052736" y="3004182"/>
            <a:ext cx="13944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2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1052736" y="5278162"/>
            <a:ext cx="13832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1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1052736" y="7252654"/>
            <a:ext cx="1311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2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11" name="Rectangle 10"/>
          <p:cNvSpPr/>
          <p:nvPr/>
        </p:nvSpPr>
        <p:spPr bwMode="auto">
          <a:xfrm>
            <a:off x="14482417" y="1025998"/>
            <a:ext cx="374954" cy="112267"/>
          </a:xfrm>
          <a:prstGeom prst="rect">
            <a:avLst/>
          </a:prstGeom>
          <a:solidFill>
            <a:schemeClr val="bg1"/>
          </a:solidFill>
          <a:ln w="762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non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marL="0" marR="0" indent="0" algn="ctr" defTabSz="41751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2" name="Rectangle 11"/>
          <p:cNvSpPr/>
          <p:nvPr/>
        </p:nvSpPr>
        <p:spPr bwMode="auto">
          <a:xfrm>
            <a:off x="14278281" y="11237884"/>
            <a:ext cx="374954" cy="112267"/>
          </a:xfrm>
          <a:prstGeom prst="rect">
            <a:avLst/>
          </a:prstGeom>
          <a:solidFill>
            <a:schemeClr val="bg1"/>
          </a:solidFill>
          <a:ln w="76200" cap="flat" cmpd="sng" algn="ctr">
            <a:solidFill>
              <a:schemeClr val="bg1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none" lIns="91440" tIns="45720" rIns="91440" bIns="45720" numCol="1" rtlCol="0" anchor="ctr" anchorCtr="0" compatLnSpc="1">
            <a:prstTxWarp prst="textNoShape">
              <a:avLst/>
            </a:prstTxWarp>
          </a:bodyPr>
          <a:lstStyle/>
          <a:p>
            <a:pPr marL="0" marR="0" indent="0" algn="ctr" defTabSz="4175125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fr-FR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7596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34" name="Image 24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696" y="7089700"/>
            <a:ext cx="5341299" cy="1963474"/>
          </a:xfrm>
          <a:prstGeom prst="rect">
            <a:avLst/>
          </a:prstGeom>
        </p:spPr>
      </p:pic>
      <p:pic>
        <p:nvPicPr>
          <p:cNvPr id="2433" name="Image 243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8538" y="5108468"/>
            <a:ext cx="5200742" cy="1911804"/>
          </a:xfrm>
          <a:prstGeom prst="rect">
            <a:avLst/>
          </a:prstGeom>
        </p:spPr>
      </p:pic>
      <p:pic>
        <p:nvPicPr>
          <p:cNvPr id="2432" name="Image 243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2696" y="2730516"/>
            <a:ext cx="5269291" cy="1949654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2696" y="652210"/>
            <a:ext cx="5737703" cy="2015590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620688" y="395536"/>
            <a:ext cx="782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rgbClr val="0070C0"/>
                </a:solidFill>
              </a:rPr>
              <a:t>TS2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620688" y="4778732"/>
            <a:ext cx="1562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rgbClr val="0070C0"/>
                </a:solidFill>
              </a:rPr>
              <a:t>ORYLUX 6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1052736" y="899592"/>
            <a:ext cx="1394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1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1052736" y="3004182"/>
            <a:ext cx="13944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2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1052736" y="5278162"/>
            <a:ext cx="13832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1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052736" y="7252654"/>
            <a:ext cx="1311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2</a:t>
            </a:r>
            <a:endParaRPr lang="fr-FR" sz="1100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10412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18" name="Image 261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970" y="7030970"/>
            <a:ext cx="5164611" cy="1941353"/>
          </a:xfrm>
          <a:prstGeom prst="rect">
            <a:avLst/>
          </a:prstGeom>
        </p:spPr>
      </p:pic>
      <p:pic>
        <p:nvPicPr>
          <p:cNvPr id="2617" name="Image 26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6086" y="5022820"/>
            <a:ext cx="5435745" cy="1997452"/>
          </a:xfrm>
          <a:prstGeom prst="rect">
            <a:avLst/>
          </a:prstGeom>
        </p:spPr>
      </p:pic>
      <p:pic>
        <p:nvPicPr>
          <p:cNvPr id="2616" name="Image 26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5264" y="2771800"/>
            <a:ext cx="5356024" cy="2003763"/>
          </a:xfrm>
          <a:prstGeom prst="rect">
            <a:avLst/>
          </a:prstGeom>
        </p:spPr>
      </p:pic>
      <p:pic>
        <p:nvPicPr>
          <p:cNvPr id="2615" name="Image 26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5264" y="668024"/>
            <a:ext cx="5400600" cy="1986048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620688" y="323528"/>
            <a:ext cx="7829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rgbClr val="0070C0"/>
                </a:solidFill>
              </a:rPr>
              <a:t>TS2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620688" y="4716016"/>
            <a:ext cx="15628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>
                <a:solidFill>
                  <a:srgbClr val="0070C0"/>
                </a:solidFill>
              </a:rPr>
              <a:t>ORYLUX 6</a:t>
            </a:r>
            <a:endParaRPr lang="fr-FR" b="1" dirty="0">
              <a:solidFill>
                <a:srgbClr val="0070C0"/>
              </a:solidFill>
            </a:endParaRPr>
          </a:p>
        </p:txBody>
      </p:sp>
      <p:sp>
        <p:nvSpPr>
          <p:cNvPr id="4" name="ZoneTexte 3"/>
          <p:cNvSpPr txBox="1"/>
          <p:nvPr/>
        </p:nvSpPr>
        <p:spPr>
          <a:xfrm>
            <a:off x="1052736" y="899592"/>
            <a:ext cx="13944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1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1052736" y="3004182"/>
            <a:ext cx="139446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2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1052736" y="5278162"/>
            <a:ext cx="13832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1</a:t>
            </a:r>
            <a:endParaRPr lang="fr-FR" sz="1100" b="1" dirty="0">
              <a:solidFill>
                <a:srgbClr val="0070C0"/>
              </a:solidFill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052736" y="7252654"/>
            <a:ext cx="13112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solidFill>
                  <a:srgbClr val="0070C0"/>
                </a:solidFill>
              </a:rPr>
              <a:t>Dispositif 2</a:t>
            </a:r>
            <a:endParaRPr lang="fr-FR" sz="1100" b="1" dirty="0">
              <a:solidFill>
                <a:srgbClr val="0070C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9151837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737</TotalTime>
  <Words>47</Words>
  <Application>Microsoft Office PowerPoint</Application>
  <PresentationFormat>Affichage à l'écran (4:3)</PresentationFormat>
  <Paragraphs>19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082-F055</dc:creator>
  <cp:lastModifiedBy>IRD</cp:lastModifiedBy>
  <cp:revision>206</cp:revision>
  <cp:lastPrinted>2021-09-07T13:47:17Z</cp:lastPrinted>
  <dcterms:created xsi:type="dcterms:W3CDTF">2013-07-12T11:54:47Z</dcterms:created>
  <dcterms:modified xsi:type="dcterms:W3CDTF">2023-11-17T22:00:39Z</dcterms:modified>
</cp:coreProperties>
</file>